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fntdata" ContentType="application/x-fontdata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embedTrueTypeFonts="1">
  <p:sldMasterIdLst>
    <p:sldMasterId id="2147483648" r:id="rId1"/>
  </p:sldMasterIdLst>
  <p:sldIdLst>
    <p:sldId id="258" r:id="rId2"/>
  </p:sldIdLst>
  <p:sldSz cx="12192000" cy="6858000"/>
  <p:notesSz cx="6858000" cy="9144000"/>
  <p:embeddedFontLst>
    <p:embeddedFont>
      <p:font typeface="Calibri" panose="020F0502020204030204" pitchFamily="34" charset="0"/>
      <p:regular r:id="rId3"/>
      <p:bold r:id="rId4"/>
      <p:italic r:id="rId5"/>
      <p:boldItalic r:id="rId6"/>
    </p:embeddedFont>
    <p:embeddedFont>
      <p:font typeface="Calibri Light" panose="020F0302020204030204" pitchFamily="34" charset="0"/>
      <p:regular r:id="rId7"/>
      <p:italic r:id="rId8"/>
    </p:embeddedFont>
  </p:embeddedFontLst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025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138" y="37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font" Target="fonts/font6.fntdata"/><Relationship Id="rId3" Type="http://schemas.openxmlformats.org/officeDocument/2006/relationships/font" Target="fonts/font1.fntdata"/><Relationship Id="rId7" Type="http://schemas.openxmlformats.org/officeDocument/2006/relationships/font" Target="fonts/font5.fntdata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font" Target="fonts/font4.fntdata"/><Relationship Id="rId11" Type="http://schemas.openxmlformats.org/officeDocument/2006/relationships/theme" Target="theme/theme1.xml"/><Relationship Id="rId5" Type="http://schemas.openxmlformats.org/officeDocument/2006/relationships/font" Target="fonts/font3.fntdata"/><Relationship Id="rId10" Type="http://schemas.openxmlformats.org/officeDocument/2006/relationships/viewProps" Target="viewProps.xml"/><Relationship Id="rId4" Type="http://schemas.openxmlformats.org/officeDocument/2006/relationships/font" Target="fonts/font2.fntdata"/><Relationship Id="rId9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4" Type="http://schemas.openxmlformats.org/officeDocument/2006/relationships/package" Target="../embeddings/Microsoft_Excel-Arbeitsblatt.xlsx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4" Type="http://schemas.openxmlformats.org/officeDocument/2006/relationships/package" Target="../embeddings/Microsoft_Excel-Arbeitsblatt1.xlsx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4" Type="http://schemas.openxmlformats.org/officeDocument/2006/relationships/package" Target="../embeddings/Microsoft_Excel-Arbeitsblatt2.xlsx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4" Type="http://schemas.openxmlformats.org/officeDocument/2006/relationships/package" Target="../embeddings/Microsoft_Excel-Arbeitsblatt3.xlsx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negativ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TCRab graphs'!$P$11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TCRab graphs'!$Q$5:$V$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TCRab graphs'!$Q$11:$V$11</c:f>
              <c:numCache>
                <c:formatCode>General</c:formatCode>
                <c:ptCount val="6"/>
                <c:pt idx="0">
                  <c:v>153644.38760000002</c:v>
                </c:pt>
                <c:pt idx="1">
                  <c:v>531878.85100000002</c:v>
                </c:pt>
                <c:pt idx="2">
                  <c:v>735513.74</c:v>
                </c:pt>
                <c:pt idx="3">
                  <c:v>762853.98600000015</c:v>
                </c:pt>
                <c:pt idx="4">
                  <c:v>909076.90981818177</c:v>
                </c:pt>
                <c:pt idx="5">
                  <c:v>1139616.283333333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622-47F3-97C7-443CCBA63B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12573032"/>
        <c:axId val="409624320"/>
      </c:lineChart>
      <c:scatterChart>
        <c:scatterStyle val="lineMarker"/>
        <c:varyColors val="0"/>
        <c:ser>
          <c:idx val="0"/>
          <c:order val="0"/>
          <c:tx>
            <c:strRef>
              <c:f>'TCRab graphs'!$P$6</c:f>
              <c:strCache>
                <c:ptCount val="1"/>
                <c:pt idx="0">
                  <c:v>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TCRab graphs'!$Q$5:$V$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6:$V$6</c:f>
              <c:numCache>
                <c:formatCode>General</c:formatCode>
                <c:ptCount val="6"/>
                <c:pt idx="0">
                  <c:v>210348.6</c:v>
                </c:pt>
                <c:pt idx="1">
                  <c:v>403570.995</c:v>
                </c:pt>
                <c:pt idx="2">
                  <c:v>488945.5</c:v>
                </c:pt>
                <c:pt idx="3">
                  <c:v>510656.96000000008</c:v>
                </c:pt>
                <c:pt idx="4">
                  <c:v>752804.60000000009</c:v>
                </c:pt>
                <c:pt idx="5">
                  <c:v>1044130.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622-47F3-97C7-443CCBA63B91}"/>
            </c:ext>
          </c:extLst>
        </c:ser>
        <c:ser>
          <c:idx val="1"/>
          <c:order val="1"/>
          <c:tx>
            <c:strRef>
              <c:f>'TCRab graphs'!$P$7</c:f>
              <c:strCache>
                <c:ptCount val="1"/>
                <c:pt idx="0">
                  <c:v>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TCRab graphs'!$Q$5:$V$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7:$V$7</c:f>
              <c:numCache>
                <c:formatCode>General</c:formatCode>
                <c:ptCount val="6"/>
                <c:pt idx="0">
                  <c:v>77932.712</c:v>
                </c:pt>
                <c:pt idx="1">
                  <c:v>873925.2</c:v>
                </c:pt>
                <c:pt idx="2">
                  <c:v>577368.00000000012</c:v>
                </c:pt>
                <c:pt idx="3">
                  <c:v>1286255.8799999999</c:v>
                </c:pt>
                <c:pt idx="4">
                  <c:v>603850</c:v>
                </c:pt>
                <c:pt idx="5">
                  <c:v>1568963.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622-47F3-97C7-443CCBA63B91}"/>
            </c:ext>
          </c:extLst>
        </c:ser>
        <c:ser>
          <c:idx val="2"/>
          <c:order val="2"/>
          <c:tx>
            <c:strRef>
              <c:f>'TCRab graphs'!$P$8</c:f>
              <c:strCache>
                <c:ptCount val="1"/>
                <c:pt idx="0">
                  <c:v>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TCRab graphs'!$Q$5:$V$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8:$V$8</c:f>
              <c:numCache>
                <c:formatCode>General</c:formatCode>
                <c:ptCount val="6"/>
                <c:pt idx="0">
                  <c:v>68033.195999999996</c:v>
                </c:pt>
                <c:pt idx="1">
                  <c:v>523924.44</c:v>
                </c:pt>
                <c:pt idx="2">
                  <c:v>1168252.8</c:v>
                </c:pt>
                <c:pt idx="3">
                  <c:v>640899.80500000005</c:v>
                </c:pt>
                <c:pt idx="4">
                  <c:v>1501615.04</c:v>
                </c:pt>
                <c:pt idx="5">
                  <c:v>805754.9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622-47F3-97C7-443CCBA63B91}"/>
            </c:ext>
          </c:extLst>
        </c:ser>
        <c:ser>
          <c:idx val="3"/>
          <c:order val="3"/>
          <c:tx>
            <c:strRef>
              <c:f>'TCRab graphs'!$P$9</c:f>
              <c:strCache>
                <c:ptCount val="1"/>
                <c:pt idx="0">
                  <c:v>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TCRab graphs'!$Q$5:$V$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9:$V$9</c:f>
              <c:numCache>
                <c:formatCode>General</c:formatCode>
                <c:ptCount val="6"/>
                <c:pt idx="0">
                  <c:v>163790.54999999999</c:v>
                </c:pt>
                <c:pt idx="1">
                  <c:v>470847.86</c:v>
                </c:pt>
                <c:pt idx="2">
                  <c:v>692244</c:v>
                </c:pt>
                <c:pt idx="3">
                  <c:v>706019.38500000001</c:v>
                </c:pt>
                <c:pt idx="4">
                  <c:v>784747.6363636362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622-47F3-97C7-443CCBA63B91}"/>
            </c:ext>
          </c:extLst>
        </c:ser>
        <c:ser>
          <c:idx val="4"/>
          <c:order val="4"/>
          <c:tx>
            <c:strRef>
              <c:f>'TCRab graphs'!$P$10</c:f>
              <c:strCache>
                <c:ptCount val="1"/>
                <c:pt idx="0">
                  <c:v>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TCRab graphs'!$Q$5:$V$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10:$V$10</c:f>
              <c:numCache>
                <c:formatCode>General</c:formatCode>
                <c:ptCount val="6"/>
                <c:pt idx="0">
                  <c:v>248116.88</c:v>
                </c:pt>
                <c:pt idx="1">
                  <c:v>387125.76000000001</c:v>
                </c:pt>
                <c:pt idx="2">
                  <c:v>750758.40000000002</c:v>
                </c:pt>
                <c:pt idx="3">
                  <c:v>670437.90000000014</c:v>
                </c:pt>
                <c:pt idx="4">
                  <c:v>902367.2727272728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622-47F3-97C7-443CCBA63B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09138992"/>
        <c:axId val="409138664"/>
      </c:scatterChart>
      <c:catAx>
        <c:axId val="41257303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09624320"/>
        <c:crosses val="autoZero"/>
        <c:auto val="1"/>
        <c:lblAlgn val="ctr"/>
        <c:lblOffset val="100"/>
        <c:noMultiLvlLbl val="0"/>
      </c:catAx>
      <c:valAx>
        <c:axId val="409624320"/>
        <c:scaling>
          <c:orientation val="minMax"/>
          <c:max val="80000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12573032"/>
        <c:crosses val="autoZero"/>
        <c:crossBetween val="between"/>
        <c:majorUnit val="1600000"/>
        <c:dispUnits>
          <c:builtInUnit val="hundredThousands"/>
          <c:dispUnitsLbl>
            <c:layout>
              <c:manualLayout>
                <c:xMode val="edge"/>
                <c:yMode val="edge"/>
                <c:x val="2.6061487948660547E-2"/>
                <c:y val="0.37264587593728699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>
                      <a:effectLst/>
                    </a:rPr>
                    <a:t>10</a:t>
                  </a:r>
                  <a:r>
                    <a:rPr lang="de-AT" sz="1000" b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09138664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409138992"/>
        <c:crosses val="max"/>
        <c:crossBetween val="midCat"/>
      </c:valAx>
      <c:valAx>
        <c:axId val="409138992"/>
        <c:scaling>
          <c:orientation val="minMax"/>
        </c:scaling>
        <c:delete val="1"/>
        <c:axPos val="t"/>
        <c:majorTickMark val="out"/>
        <c:minorTickMark val="none"/>
        <c:tickLblPos val="nextTo"/>
        <c:crossAx val="409138664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ion-only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TCRab graphs'!$P$21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TCRab graphs'!$Q$15:$V$1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TCRab graphs'!$Q$21:$V$21</c:f>
              <c:numCache>
                <c:formatCode>General</c:formatCode>
                <c:ptCount val="6"/>
                <c:pt idx="0">
                  <c:v>146071.87400000001</c:v>
                </c:pt>
                <c:pt idx="1">
                  <c:v>916819.43</c:v>
                </c:pt>
                <c:pt idx="2">
                  <c:v>2397282.8400000003</c:v>
                </c:pt>
                <c:pt idx="3">
                  <c:v>1642788.2900000003</c:v>
                </c:pt>
                <c:pt idx="4">
                  <c:v>846999.87599999993</c:v>
                </c:pt>
                <c:pt idx="5">
                  <c:v>2455858.28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982-4F6B-9CA5-13DAC9CF78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12574016"/>
        <c:axId val="418205648"/>
      </c:lineChart>
      <c:scatterChart>
        <c:scatterStyle val="lineMarker"/>
        <c:varyColors val="0"/>
        <c:ser>
          <c:idx val="0"/>
          <c:order val="0"/>
          <c:tx>
            <c:strRef>
              <c:f>'TCRab graphs'!$P$16</c:f>
              <c:strCache>
                <c:ptCount val="1"/>
                <c:pt idx="0">
                  <c:v>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TCRab graphs'!$Q$15:$V$1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16:$V$16</c:f>
              <c:numCache>
                <c:formatCode>General</c:formatCode>
                <c:ptCount val="6"/>
                <c:pt idx="0">
                  <c:v>286835.25</c:v>
                </c:pt>
                <c:pt idx="1">
                  <c:v>1435434</c:v>
                </c:pt>
                <c:pt idx="2">
                  <c:v>2221708</c:v>
                </c:pt>
                <c:pt idx="3">
                  <c:v>2308628.85</c:v>
                </c:pt>
                <c:pt idx="4">
                  <c:v>884453.04</c:v>
                </c:pt>
                <c:pt idx="5">
                  <c:v>4384094.400000000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C982-4F6B-9CA5-13DAC9CF7831}"/>
            </c:ext>
          </c:extLst>
        </c:ser>
        <c:ser>
          <c:idx val="1"/>
          <c:order val="1"/>
          <c:tx>
            <c:strRef>
              <c:f>'TCRab graphs'!$P$17</c:f>
              <c:strCache>
                <c:ptCount val="1"/>
                <c:pt idx="0">
                  <c:v>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TCRab graphs'!$Q$15:$V$1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17:$V$17</c:f>
              <c:numCache>
                <c:formatCode>General</c:formatCode>
                <c:ptCount val="6"/>
                <c:pt idx="0">
                  <c:v>201590.39999999999</c:v>
                </c:pt>
                <c:pt idx="1">
                  <c:v>826107.75</c:v>
                </c:pt>
                <c:pt idx="2">
                  <c:v>2843100</c:v>
                </c:pt>
                <c:pt idx="3">
                  <c:v>1582468.8</c:v>
                </c:pt>
                <c:pt idx="4">
                  <c:v>1307049.3999999999</c:v>
                </c:pt>
                <c:pt idx="5">
                  <c:v>2086533.799999999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C982-4F6B-9CA5-13DAC9CF7831}"/>
            </c:ext>
          </c:extLst>
        </c:ser>
        <c:ser>
          <c:idx val="2"/>
          <c:order val="2"/>
          <c:tx>
            <c:strRef>
              <c:f>'TCRab graphs'!$P$18</c:f>
              <c:strCache>
                <c:ptCount val="1"/>
                <c:pt idx="0">
                  <c:v>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TCRab graphs'!$Q$15:$V$1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18:$V$18</c:f>
              <c:numCache>
                <c:formatCode>General</c:formatCode>
                <c:ptCount val="6"/>
                <c:pt idx="0">
                  <c:v>71270.303999999989</c:v>
                </c:pt>
                <c:pt idx="1">
                  <c:v>1217854.6000000001</c:v>
                </c:pt>
                <c:pt idx="2">
                  <c:v>1642855.5000000002</c:v>
                </c:pt>
                <c:pt idx="3">
                  <c:v>2104848</c:v>
                </c:pt>
                <c:pt idx="4">
                  <c:v>598823.93999999994</c:v>
                </c:pt>
                <c:pt idx="5">
                  <c:v>896946.6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C982-4F6B-9CA5-13DAC9CF7831}"/>
            </c:ext>
          </c:extLst>
        </c:ser>
        <c:ser>
          <c:idx val="3"/>
          <c:order val="3"/>
          <c:tx>
            <c:strRef>
              <c:f>'TCRab graphs'!$P$19</c:f>
              <c:strCache>
                <c:ptCount val="1"/>
                <c:pt idx="0">
                  <c:v>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TCRab graphs'!$Q$15:$V$1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19:$V$19</c:f>
              <c:numCache>
                <c:formatCode>General</c:formatCode>
                <c:ptCount val="6"/>
                <c:pt idx="0">
                  <c:v>141609.31000000003</c:v>
                </c:pt>
                <c:pt idx="1">
                  <c:v>381942.4</c:v>
                </c:pt>
                <c:pt idx="2">
                  <c:v>2123960.2999999998</c:v>
                </c:pt>
                <c:pt idx="3">
                  <c:v>1031045.4</c:v>
                </c:pt>
                <c:pt idx="4">
                  <c:v>1018612.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C982-4F6B-9CA5-13DAC9CF7831}"/>
            </c:ext>
          </c:extLst>
        </c:ser>
        <c:ser>
          <c:idx val="4"/>
          <c:order val="4"/>
          <c:tx>
            <c:strRef>
              <c:f>'TCRab graphs'!$P$20</c:f>
              <c:strCache>
                <c:ptCount val="1"/>
                <c:pt idx="0">
                  <c:v>1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TCRab graphs'!$Q$15:$V$1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20:$V$20</c:f>
              <c:numCache>
                <c:formatCode>General</c:formatCode>
                <c:ptCount val="6"/>
                <c:pt idx="0">
                  <c:v>29054.106000000007</c:v>
                </c:pt>
                <c:pt idx="1">
                  <c:v>722758.4</c:v>
                </c:pt>
                <c:pt idx="2">
                  <c:v>3154790.3999999999</c:v>
                </c:pt>
                <c:pt idx="3">
                  <c:v>1186950.3999999999</c:v>
                </c:pt>
                <c:pt idx="4">
                  <c:v>426060.8000000000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C982-4F6B-9CA5-13DAC9CF783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8410528"/>
        <c:axId val="418410200"/>
      </c:scatterChart>
      <c:catAx>
        <c:axId val="412574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18205648"/>
        <c:crosses val="autoZero"/>
        <c:auto val="1"/>
        <c:lblAlgn val="ctr"/>
        <c:lblOffset val="100"/>
        <c:noMultiLvlLbl val="0"/>
      </c:catAx>
      <c:valAx>
        <c:axId val="418205648"/>
        <c:scaling>
          <c:orientation val="minMax"/>
          <c:max val="8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12574016"/>
        <c:crosses val="autoZero"/>
        <c:crossBetween val="between"/>
        <c:majorUnit val="1600000"/>
        <c:minorUnit val="200000"/>
        <c:dispUnits>
          <c:builtInUnit val="hundredThousands"/>
          <c:dispUnitsLbl>
            <c:layout>
              <c:manualLayout>
                <c:xMode val="edge"/>
                <c:yMode val="edge"/>
                <c:x val="2.3692261771509588E-2"/>
                <c:y val="0.37264587593728699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>
                      <a:effectLst/>
                    </a:rPr>
                    <a:t>10</a:t>
                  </a:r>
                  <a:r>
                    <a:rPr lang="de-AT" sz="1000" b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18410200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418410528"/>
        <c:crosses val="max"/>
        <c:crossBetween val="midCat"/>
      </c:valAx>
      <c:valAx>
        <c:axId val="418410528"/>
        <c:scaling>
          <c:orientation val="minMax"/>
        </c:scaling>
        <c:delete val="1"/>
        <c:axPos val="t"/>
        <c:majorTickMark val="out"/>
        <c:minorTickMark val="none"/>
        <c:tickLblPos val="nextTo"/>
        <c:crossAx val="418410200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challenge control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TCRab graphs'!$P$31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TCRab graphs'!$Q$25:$V$2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cat>
          <c:val>
            <c:numRef>
              <c:f>'TCRab graphs'!$Q$31:$V$31</c:f>
              <c:numCache>
                <c:formatCode>General</c:formatCode>
                <c:ptCount val="6"/>
                <c:pt idx="0">
                  <c:v>82631.771919999999</c:v>
                </c:pt>
                <c:pt idx="1">
                  <c:v>1360442.25</c:v>
                </c:pt>
                <c:pt idx="2">
                  <c:v>2777924.1540000001</c:v>
                </c:pt>
                <c:pt idx="3">
                  <c:v>4440851.22</c:v>
                </c:pt>
                <c:pt idx="4">
                  <c:v>3296787.66</c:v>
                </c:pt>
                <c:pt idx="5">
                  <c:v>3319771.23333333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5784-4112-8FC7-5D111D5FC9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16689096"/>
        <c:axId val="416689752"/>
      </c:lineChart>
      <c:scatterChart>
        <c:scatterStyle val="lineMarker"/>
        <c:varyColors val="0"/>
        <c:ser>
          <c:idx val="0"/>
          <c:order val="0"/>
          <c:tx>
            <c:strRef>
              <c:f>'TCRab graphs'!$P$26</c:f>
              <c:strCache>
                <c:ptCount val="1"/>
                <c:pt idx="0">
                  <c:v>11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TCRab graphs'!$Q$25:$V$2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26:$V$26</c:f>
              <c:numCache>
                <c:formatCode>General</c:formatCode>
                <c:ptCount val="6"/>
                <c:pt idx="0">
                  <c:v>181228.32</c:v>
                </c:pt>
                <c:pt idx="1">
                  <c:v>1143474.75</c:v>
                </c:pt>
                <c:pt idx="2">
                  <c:v>2083228.4499999997</c:v>
                </c:pt>
                <c:pt idx="3">
                  <c:v>5514982.2000000002</c:v>
                </c:pt>
                <c:pt idx="4">
                  <c:v>3672004.35</c:v>
                </c:pt>
                <c:pt idx="5">
                  <c:v>5073222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5784-4112-8FC7-5D111D5FC936}"/>
            </c:ext>
          </c:extLst>
        </c:ser>
        <c:ser>
          <c:idx val="1"/>
          <c:order val="1"/>
          <c:tx>
            <c:strRef>
              <c:f>'TCRab graphs'!$P$27</c:f>
              <c:strCache>
                <c:ptCount val="1"/>
                <c:pt idx="0">
                  <c:v>12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TCRab graphs'!$Q$25:$V$2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27:$V$27</c:f>
              <c:numCache>
                <c:formatCode>General</c:formatCode>
                <c:ptCount val="6"/>
                <c:pt idx="0">
                  <c:v>64326.675600000002</c:v>
                </c:pt>
                <c:pt idx="1">
                  <c:v>1405760</c:v>
                </c:pt>
                <c:pt idx="2">
                  <c:v>4604169.6000000006</c:v>
                </c:pt>
                <c:pt idx="3">
                  <c:v>4106543.4999999995</c:v>
                </c:pt>
                <c:pt idx="4">
                  <c:v>2600812.5</c:v>
                </c:pt>
                <c:pt idx="5">
                  <c:v>1550963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5784-4112-8FC7-5D111D5FC936}"/>
            </c:ext>
          </c:extLst>
        </c:ser>
        <c:ser>
          <c:idx val="2"/>
          <c:order val="2"/>
          <c:tx>
            <c:strRef>
              <c:f>'TCRab graphs'!$P$28</c:f>
              <c:strCache>
                <c:ptCount val="1"/>
                <c:pt idx="0">
                  <c:v>13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TCRab graphs'!$Q$25:$V$2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28:$V$28</c:f>
              <c:numCache>
                <c:formatCode>General</c:formatCode>
                <c:ptCount val="6"/>
                <c:pt idx="0">
                  <c:v>79283.995999999999</c:v>
                </c:pt>
                <c:pt idx="1">
                  <c:v>2092276.2</c:v>
                </c:pt>
                <c:pt idx="2">
                  <c:v>2352571.0000000005</c:v>
                </c:pt>
                <c:pt idx="3">
                  <c:v>3403238</c:v>
                </c:pt>
                <c:pt idx="4">
                  <c:v>3376116</c:v>
                </c:pt>
                <c:pt idx="5">
                  <c:v>333512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5784-4112-8FC7-5D111D5FC936}"/>
            </c:ext>
          </c:extLst>
        </c:ser>
        <c:ser>
          <c:idx val="3"/>
          <c:order val="3"/>
          <c:tx>
            <c:strRef>
              <c:f>'TCRab graphs'!$P$29</c:f>
              <c:strCache>
                <c:ptCount val="1"/>
                <c:pt idx="0">
                  <c:v>14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TCRab graphs'!$Q$25:$V$2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29:$V$29</c:f>
              <c:numCache>
                <c:formatCode>General</c:formatCode>
                <c:ptCount val="6"/>
                <c:pt idx="0">
                  <c:v>49981.932000000001</c:v>
                </c:pt>
                <c:pt idx="1">
                  <c:v>1152576.7000000002</c:v>
                </c:pt>
                <c:pt idx="2">
                  <c:v>3242197</c:v>
                </c:pt>
                <c:pt idx="3">
                  <c:v>6767416.5</c:v>
                </c:pt>
                <c:pt idx="4">
                  <c:v>2661984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5784-4112-8FC7-5D111D5FC936}"/>
            </c:ext>
          </c:extLst>
        </c:ser>
        <c:ser>
          <c:idx val="4"/>
          <c:order val="4"/>
          <c:tx>
            <c:strRef>
              <c:f>'TCRab graphs'!$P$30</c:f>
              <c:strCache>
                <c:ptCount val="1"/>
                <c:pt idx="0">
                  <c:v>15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TCRab graphs'!$Q$25:$V$25</c:f>
              <c:strCache>
                <c:ptCount val="6"/>
                <c:pt idx="0">
                  <c:v>13 dpv</c:v>
                </c:pt>
                <c:pt idx="1">
                  <c:v>20 dpv</c:v>
                </c:pt>
                <c:pt idx="2">
                  <c:v>3 dpc</c:v>
                </c:pt>
                <c:pt idx="3">
                  <c:v>5 dpc</c:v>
                </c:pt>
                <c:pt idx="4">
                  <c:v>7 dpc</c:v>
                </c:pt>
                <c:pt idx="5">
                  <c:v>14 dpc</c:v>
                </c:pt>
              </c:strCache>
            </c:strRef>
          </c:xVal>
          <c:yVal>
            <c:numRef>
              <c:f>'TCRab graphs'!$Q$30:$V$30</c:f>
              <c:numCache>
                <c:formatCode>General</c:formatCode>
                <c:ptCount val="6"/>
                <c:pt idx="0">
                  <c:v>38337.936000000002</c:v>
                </c:pt>
                <c:pt idx="1">
                  <c:v>1008123.6</c:v>
                </c:pt>
                <c:pt idx="2">
                  <c:v>1607454.72</c:v>
                </c:pt>
                <c:pt idx="3">
                  <c:v>2412075.9</c:v>
                </c:pt>
                <c:pt idx="4">
                  <c:v>4173021.45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5784-4112-8FC7-5D111D5FC936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2481424"/>
        <c:axId val="382481752"/>
      </c:scatterChart>
      <c:catAx>
        <c:axId val="41668909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16689752"/>
        <c:crosses val="autoZero"/>
        <c:auto val="1"/>
        <c:lblAlgn val="ctr"/>
        <c:lblOffset val="100"/>
        <c:noMultiLvlLbl val="0"/>
      </c:catAx>
      <c:valAx>
        <c:axId val="416689752"/>
        <c:scaling>
          <c:orientation val="minMax"/>
          <c:max val="8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16689096"/>
        <c:crosses val="autoZero"/>
        <c:crossBetween val="between"/>
        <c:majorUnit val="1600000"/>
        <c:dispUnits>
          <c:builtInUnit val="hundredThousands"/>
          <c:dispUnitsLbl>
            <c:layout>
              <c:manualLayout>
                <c:xMode val="edge"/>
                <c:yMode val="edge"/>
                <c:x val="2.6061487948660547E-2"/>
                <c:y val="0.38563156100886165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>
                      <a:effectLst/>
                    </a:rPr>
                    <a:t>10</a:t>
                  </a:r>
                  <a:r>
                    <a:rPr lang="de-AT" sz="1000" b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382481752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382481424"/>
        <c:crosses val="max"/>
        <c:crossBetween val="midCat"/>
      </c:valAx>
      <c:valAx>
        <c:axId val="382481424"/>
        <c:scaling>
          <c:orientation val="minMax"/>
        </c:scaling>
        <c:delete val="1"/>
        <c:axPos val="t"/>
        <c:majorTickMark val="out"/>
        <c:minorTickMark val="none"/>
        <c:tickLblPos val="nextTo"/>
        <c:crossAx val="382481752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de-AT"/>
              <a:t>vaccinated/challenged</a:t>
            </a:r>
          </a:p>
        </c:rich>
      </c:tx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spc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title>
    <c:autoTitleDeleted val="0"/>
    <c:plotArea>
      <c:layout/>
      <c:lineChart>
        <c:grouping val="standard"/>
        <c:varyColors val="0"/>
        <c:ser>
          <c:idx val="5"/>
          <c:order val="5"/>
          <c:tx>
            <c:strRef>
              <c:f>'TCRab graphs'!$Q$41</c:f>
              <c:strCache>
                <c:ptCount val="1"/>
                <c:pt idx="0">
                  <c:v>mean</c:v>
                </c:pt>
              </c:strCache>
            </c:strRef>
          </c:tx>
          <c:spPr>
            <a:ln w="28575" cap="rnd">
              <a:solidFill>
                <a:schemeClr val="tx1"/>
              </a:solidFill>
              <a:round/>
            </a:ln>
            <a:effectLst/>
          </c:spPr>
          <c:marker>
            <c:symbol val="none"/>
          </c:marker>
          <c:cat>
            <c:strRef>
              <c:f>'TCRab graphs'!$R$35:$V$35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cat>
          <c:val>
            <c:numRef>
              <c:f>'TCRab graphs'!$R$41:$V$41</c:f>
              <c:numCache>
                <c:formatCode>General</c:formatCode>
                <c:ptCount val="5"/>
                <c:pt idx="0">
                  <c:v>1674340.2</c:v>
                </c:pt>
                <c:pt idx="1">
                  <c:v>3310963.7680000002</c:v>
                </c:pt>
                <c:pt idx="2">
                  <c:v>1631223.898</c:v>
                </c:pt>
                <c:pt idx="3">
                  <c:v>2154397.716</c:v>
                </c:pt>
                <c:pt idx="4">
                  <c:v>1584617.200000000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6F4-45BD-9313-BC86862AD2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418206960"/>
        <c:axId val="419099040"/>
      </c:lineChart>
      <c:scatterChart>
        <c:scatterStyle val="lineMarker"/>
        <c:varyColors val="0"/>
        <c:ser>
          <c:idx val="0"/>
          <c:order val="0"/>
          <c:tx>
            <c:strRef>
              <c:f>'TCRab graphs'!$Q$36</c:f>
              <c:strCache>
                <c:ptCount val="1"/>
                <c:pt idx="0">
                  <c:v>16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xVal>
            <c:strRef>
              <c:f>'TCRab graphs'!$R$35:$V$35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ab graphs'!$R$36:$V$36</c:f>
              <c:numCache>
                <c:formatCode>General</c:formatCode>
                <c:ptCount val="5"/>
                <c:pt idx="0">
                  <c:v>744559.2</c:v>
                </c:pt>
                <c:pt idx="1">
                  <c:v>3206200</c:v>
                </c:pt>
                <c:pt idx="2">
                  <c:v>1786691.2</c:v>
                </c:pt>
                <c:pt idx="3">
                  <c:v>667832.88000000012</c:v>
                </c:pt>
                <c:pt idx="4">
                  <c:v>1668732.8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1-E6F4-45BD-9313-BC86862AD2D4}"/>
            </c:ext>
          </c:extLst>
        </c:ser>
        <c:ser>
          <c:idx val="1"/>
          <c:order val="1"/>
          <c:tx>
            <c:strRef>
              <c:f>'TCRab graphs'!$Q$37</c:f>
              <c:strCache>
                <c:ptCount val="1"/>
                <c:pt idx="0">
                  <c:v>17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xVal>
            <c:strRef>
              <c:f>'TCRab graphs'!$R$35:$V$35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ab graphs'!$R$37:$V$37</c:f>
              <c:numCache>
                <c:formatCode>General</c:formatCode>
                <c:ptCount val="5"/>
                <c:pt idx="0">
                  <c:v>1001571.55</c:v>
                </c:pt>
                <c:pt idx="1">
                  <c:v>3877599.6</c:v>
                </c:pt>
                <c:pt idx="2">
                  <c:v>1301286.69</c:v>
                </c:pt>
                <c:pt idx="3">
                  <c:v>2290259.9999999995</c:v>
                </c:pt>
                <c:pt idx="4">
                  <c:v>1500501.6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2-E6F4-45BD-9313-BC86862AD2D4}"/>
            </c:ext>
          </c:extLst>
        </c:ser>
        <c:ser>
          <c:idx val="2"/>
          <c:order val="2"/>
          <c:tx>
            <c:strRef>
              <c:f>'TCRab graphs'!$Q$38</c:f>
              <c:strCache>
                <c:ptCount val="1"/>
                <c:pt idx="0">
                  <c:v>18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xVal>
            <c:strRef>
              <c:f>'TCRab graphs'!$R$35:$V$35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ab graphs'!$R$38:$V$38</c:f>
              <c:numCache>
                <c:formatCode>General</c:formatCode>
                <c:ptCount val="5"/>
                <c:pt idx="0">
                  <c:v>3295720.4</c:v>
                </c:pt>
                <c:pt idx="1">
                  <c:v>4825392.0000000009</c:v>
                </c:pt>
                <c:pt idx="2">
                  <c:v>1339161.6000000001</c:v>
                </c:pt>
                <c:pt idx="3">
                  <c:v>1879498.9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3-E6F4-45BD-9313-BC86862AD2D4}"/>
            </c:ext>
          </c:extLst>
        </c:ser>
        <c:ser>
          <c:idx val="3"/>
          <c:order val="3"/>
          <c:tx>
            <c:strRef>
              <c:f>'TCRab graphs'!$Q$39</c:f>
              <c:strCache>
                <c:ptCount val="1"/>
                <c:pt idx="0">
                  <c:v>19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xVal>
            <c:strRef>
              <c:f>'TCRab graphs'!$R$35:$V$35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ab graphs'!$R$39:$V$39</c:f>
              <c:numCache>
                <c:formatCode>General</c:formatCode>
                <c:ptCount val="5"/>
                <c:pt idx="0">
                  <c:v>2201177.25</c:v>
                </c:pt>
                <c:pt idx="1">
                  <c:v>2873000.2</c:v>
                </c:pt>
                <c:pt idx="2">
                  <c:v>1087210</c:v>
                </c:pt>
                <c:pt idx="3">
                  <c:v>2972662.7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4-E6F4-45BD-9313-BC86862AD2D4}"/>
            </c:ext>
          </c:extLst>
        </c:ser>
        <c:ser>
          <c:idx val="4"/>
          <c:order val="4"/>
          <c:tx>
            <c:strRef>
              <c:f>'TCRab graphs'!$Q$40</c:f>
              <c:strCache>
                <c:ptCount val="1"/>
                <c:pt idx="0">
                  <c:v>20</c:v>
                </c:pt>
              </c:strCache>
            </c:strRef>
          </c:tx>
          <c:spPr>
            <a:ln w="25400" cap="rnd">
              <a:noFill/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xVal>
            <c:strRef>
              <c:f>'TCRab graphs'!$R$35:$V$35</c:f>
              <c:strCache>
                <c:ptCount val="5"/>
                <c:pt idx="0">
                  <c:v>20 dpv</c:v>
                </c:pt>
                <c:pt idx="1">
                  <c:v>3 dpc</c:v>
                </c:pt>
                <c:pt idx="2">
                  <c:v>5 dpc</c:v>
                </c:pt>
                <c:pt idx="3">
                  <c:v>7 dpc</c:v>
                </c:pt>
                <c:pt idx="4">
                  <c:v>14 dpc</c:v>
                </c:pt>
              </c:strCache>
            </c:strRef>
          </c:xVal>
          <c:yVal>
            <c:numRef>
              <c:f>'TCRab graphs'!$R$40:$V$40</c:f>
              <c:numCache>
                <c:formatCode>General</c:formatCode>
                <c:ptCount val="5"/>
                <c:pt idx="0">
                  <c:v>1128672.6000000001</c:v>
                </c:pt>
                <c:pt idx="1">
                  <c:v>1772627.04</c:v>
                </c:pt>
                <c:pt idx="2">
                  <c:v>2641770</c:v>
                </c:pt>
                <c:pt idx="3">
                  <c:v>2961734.1</c:v>
                </c:pt>
              </c:numCache>
            </c:numRef>
          </c:yVal>
          <c:smooth val="0"/>
          <c:extLst>
            <c:ext xmlns:c16="http://schemas.microsoft.com/office/drawing/2014/chart" uri="{C3380CC4-5D6E-409C-BE32-E72D297353CC}">
              <c16:uniqueId val="{00000005-E6F4-45BD-9313-BC86862AD2D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410061992"/>
        <c:axId val="410061336"/>
      </c:scatterChart>
      <c:catAx>
        <c:axId val="418206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19099040"/>
        <c:crosses val="autoZero"/>
        <c:auto val="1"/>
        <c:lblAlgn val="ctr"/>
        <c:lblOffset val="100"/>
        <c:noMultiLvlLbl val="0"/>
      </c:catAx>
      <c:valAx>
        <c:axId val="419099040"/>
        <c:scaling>
          <c:orientation val="minMax"/>
          <c:max val="800000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de-DE"/>
          </a:p>
        </c:txPr>
        <c:crossAx val="418206960"/>
        <c:crosses val="autoZero"/>
        <c:crossBetween val="between"/>
        <c:majorUnit val="1600000"/>
        <c:dispUnits>
          <c:builtInUnit val="hundredThousands"/>
          <c:dispUnitsLbl>
            <c:layout>
              <c:manualLayout>
                <c:xMode val="edge"/>
                <c:yMode val="edge"/>
                <c:x val="2.6061487948660547E-2"/>
                <c:y val="0.38130299931833672"/>
              </c:manualLayout>
            </c:layout>
            <c:tx>
              <c:rich>
                <a:bodyPr rot="-5400000" spcFirstLastPara="1" vertOverflow="ellipsis" vert="horz" wrap="square" anchor="ctr" anchorCtr="1"/>
                <a:lstStyle/>
                <a:p>
                  <a:pPr>
                    <a:defRPr sz="1000" b="0" i="0" u="none" strike="noStrike" kern="1200" baseline="0"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de-AT" sz="1000" b="0">
                      <a:effectLst/>
                    </a:rPr>
                    <a:t>10</a:t>
                  </a:r>
                  <a:r>
                    <a:rPr lang="de-AT" sz="1000" b="0" baseline="30000">
                      <a:effectLst/>
                    </a:rPr>
                    <a:t>5 </a:t>
                  </a:r>
                  <a:r>
                    <a:rPr lang="de-AT" sz="1000" b="0" i="0" u="none" strike="noStrike" baseline="0">
                      <a:effectLst/>
                    </a:rPr>
                    <a:t>cells</a:t>
                  </a:r>
                  <a:r>
                    <a:rPr lang="de-AT" sz="1000" b="0">
                      <a:effectLst/>
                    </a:rPr>
                    <a:t>/ml</a:t>
                  </a:r>
                </a:p>
              </c:rich>
            </c:tx>
            <c:spPr>
              <a:noFill/>
              <a:ln>
                <a:noFill/>
              </a:ln>
              <a:effectLst/>
            </c:spPr>
            <c:txPr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endParaRPr lang="de-DE"/>
              </a:p>
            </c:txPr>
          </c:dispUnitsLbl>
        </c:dispUnits>
      </c:valAx>
      <c:valAx>
        <c:axId val="410061336"/>
        <c:scaling>
          <c:orientation val="minMax"/>
        </c:scaling>
        <c:delete val="1"/>
        <c:axPos val="r"/>
        <c:numFmt formatCode="General" sourceLinked="1"/>
        <c:majorTickMark val="out"/>
        <c:minorTickMark val="none"/>
        <c:tickLblPos val="nextTo"/>
        <c:crossAx val="410061992"/>
        <c:crosses val="max"/>
        <c:crossBetween val="midCat"/>
      </c:valAx>
      <c:valAx>
        <c:axId val="410061992"/>
        <c:scaling>
          <c:orientation val="minMax"/>
        </c:scaling>
        <c:delete val="1"/>
        <c:axPos val="t"/>
        <c:majorTickMark val="out"/>
        <c:minorTickMark val="none"/>
        <c:tickLblPos val="nextTo"/>
        <c:crossAx val="410061336"/>
        <c:crosses val="max"/>
        <c:crossBetween val="midCat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9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de-DE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de-DE"/>
    </a:p>
  </c:txPr>
  <c:externalData r:id="rId4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9462940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525335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8740298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216784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1903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337033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31989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570892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696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1054837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549326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A535F68-5CFD-4566-A7FF-B5BD41AAF4CA}" type="datetimeFigureOut">
              <a:rPr lang="en-GB" smtClean="0"/>
              <a:t>30/07/2020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A8D037-0270-4989-B86F-8C754CBB28D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167036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337393" y="181408"/>
            <a:ext cx="11239972" cy="6313323"/>
            <a:chOff x="337393" y="181408"/>
            <a:chExt cx="11239972" cy="6313323"/>
          </a:xfrm>
        </p:grpSpPr>
        <p:grpSp>
          <p:nvGrpSpPr>
            <p:cNvPr id="4" name="Group 3"/>
            <p:cNvGrpSpPr/>
            <p:nvPr/>
          </p:nvGrpSpPr>
          <p:grpSpPr>
            <a:xfrm>
              <a:off x="337393" y="181408"/>
              <a:ext cx="11239972" cy="6313323"/>
              <a:chOff x="337393" y="181408"/>
              <a:chExt cx="11239972" cy="6313323"/>
            </a:xfrm>
          </p:grpSpPr>
          <p:graphicFrame>
            <p:nvGraphicFramePr>
              <p:cNvPr id="15" name="Chart 14"/>
              <p:cNvGraphicFramePr/>
              <p:nvPr>
                <p:extLst>
                  <p:ext uri="{D42A27DB-BD31-4B8C-83A1-F6EECF244321}">
                    <p14:modId xmlns:p14="http://schemas.microsoft.com/office/powerpoint/2010/main" val="3576035259"/>
                  </p:ext>
                </p:extLst>
              </p:nvPr>
            </p:nvGraphicFramePr>
            <p:xfrm>
              <a:off x="337393" y="240569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graphicFrame>
            <p:nvGraphicFramePr>
              <p:cNvPr id="16" name="Chart 15"/>
              <p:cNvGraphicFramePr/>
              <p:nvPr>
                <p:extLst>
                  <p:ext uri="{D42A27DB-BD31-4B8C-83A1-F6EECF244321}">
                    <p14:modId xmlns:p14="http://schemas.microsoft.com/office/powerpoint/2010/main" val="437668530"/>
                  </p:ext>
                </p:extLst>
              </p:nvPr>
            </p:nvGraphicFramePr>
            <p:xfrm>
              <a:off x="6216965" y="240569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17" name="Chart 16"/>
              <p:cNvGraphicFramePr/>
              <p:nvPr>
                <p:extLst>
                  <p:ext uri="{D42A27DB-BD31-4B8C-83A1-F6EECF244321}">
                    <p14:modId xmlns:p14="http://schemas.microsoft.com/office/powerpoint/2010/main" val="2156134884"/>
                  </p:ext>
                </p:extLst>
              </p:nvPr>
            </p:nvGraphicFramePr>
            <p:xfrm>
              <a:off x="337393" y="3560731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aphicFrame>
            <p:nvGraphicFramePr>
              <p:cNvPr id="18" name="Chart 17"/>
              <p:cNvGraphicFramePr/>
              <p:nvPr>
                <p:extLst>
                  <p:ext uri="{D42A27DB-BD31-4B8C-83A1-F6EECF244321}">
                    <p14:modId xmlns:p14="http://schemas.microsoft.com/office/powerpoint/2010/main" val="2329504922"/>
                  </p:ext>
                </p:extLst>
              </p:nvPr>
            </p:nvGraphicFramePr>
            <p:xfrm>
              <a:off x="6216965" y="3560731"/>
              <a:ext cx="5360400" cy="29340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sp>
            <p:nvSpPr>
              <p:cNvPr id="8" name="TextBox 7"/>
              <p:cNvSpPr txBox="1"/>
              <p:nvPr/>
            </p:nvSpPr>
            <p:spPr>
              <a:xfrm>
                <a:off x="337393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/>
                  <a:t>A</a:t>
                </a:r>
              </a:p>
            </p:txBody>
          </p:sp>
          <p:sp>
            <p:nvSpPr>
              <p:cNvPr id="9" name="TextBox 8"/>
              <p:cNvSpPr txBox="1"/>
              <p:nvPr/>
            </p:nvSpPr>
            <p:spPr>
              <a:xfrm>
                <a:off x="6185622" y="181408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B</a:t>
                </a:r>
                <a:endParaRPr lang="en-GB" dirty="0"/>
              </a:p>
            </p:txBody>
          </p:sp>
          <p:sp>
            <p:nvSpPr>
              <p:cNvPr id="10" name="TextBox 9"/>
              <p:cNvSpPr txBox="1"/>
              <p:nvPr/>
            </p:nvSpPr>
            <p:spPr>
              <a:xfrm>
                <a:off x="337393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C</a:t>
                </a:r>
                <a:endParaRPr lang="en-GB" dirty="0"/>
              </a:p>
            </p:txBody>
          </p:sp>
          <p:sp>
            <p:nvSpPr>
              <p:cNvPr id="11" name="TextBox 10"/>
              <p:cNvSpPr txBox="1"/>
              <p:nvPr/>
            </p:nvSpPr>
            <p:spPr>
              <a:xfrm>
                <a:off x="6185622" y="3560731"/>
                <a:ext cx="311433" cy="3693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GB" dirty="0" smtClean="0"/>
                  <a:t>D</a:t>
                </a:r>
                <a:endParaRPr lang="en-GB" dirty="0"/>
              </a:p>
            </p:txBody>
          </p:sp>
        </p:grpSp>
        <p:sp>
          <p:nvSpPr>
            <p:cNvPr id="23" name="TextBox 22"/>
            <p:cNvSpPr txBox="1"/>
            <p:nvPr/>
          </p:nvSpPr>
          <p:spPr>
            <a:xfrm>
              <a:off x="8627174" y="1580622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9409768" y="1783069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3527953" y="4056711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749477" y="4563340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4310547" y="4666629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1976636" y="5151182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9953465" y="4945237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9018471" y="5027731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8089356" y="4506730"/>
              <a:ext cx="180756" cy="28684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000000"/>
                  </a:solidFill>
                  <a:latin typeface="Calibri" panose="020F0502020204030204" pitchFamily="34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*</a:t>
              </a:r>
              <a:endParaRPr lang="de-AT" sz="12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78486827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游ゴシック Light"/>
      <a:font script="Hang" typeface="맑은 고딕"/>
      <a:font script="Hans" typeface="等线 Light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游明朝"/>
      <a:font script="Hang" typeface="맑은 고딕"/>
      <a:font script="Hans" typeface="等线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9</Words>
  <Application>Microsoft Office PowerPoint</Application>
  <PresentationFormat>Widescreen</PresentationFormat>
  <Paragraphs>1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Calibri</vt:lpstr>
      <vt:lpstr>Calibri Light</vt:lpstr>
      <vt:lpstr>Times New Roman</vt:lpstr>
      <vt:lpstr>Arial</vt:lpstr>
      <vt:lpstr>Office Theme</vt:lpstr>
      <vt:lpstr>PowerPoint Presentation</vt:lpstr>
    </vt:vector>
  </TitlesOfParts>
  <Company>Vetmeduni Vienn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 Luca Carlotta</dc:creator>
  <cp:lastModifiedBy>De Luca Carlotta</cp:lastModifiedBy>
  <cp:revision>11</cp:revision>
  <dcterms:created xsi:type="dcterms:W3CDTF">2020-07-30T11:05:44Z</dcterms:created>
  <dcterms:modified xsi:type="dcterms:W3CDTF">2020-07-30T12:22:35Z</dcterms:modified>
</cp:coreProperties>
</file>